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A3719-60FF-441F-9AC6-9A983FB699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098BD-631A-4B9B-9CD5-CB34BAF442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5DCFA-FBA1-426B-9D9F-A37F811852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6F8A7-40A3-488B-8713-0F633EC478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FD252-383A-4810-BC2D-5EB9DFD2FC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32684-6645-4088-80E2-7F54E84205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F0502-2740-4F37-AF20-6EF4BDEC57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2EB48-2D6E-4F84-B321-BBCA8C7257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6606B-87A1-40DB-9130-B955966593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EDDC0-8F90-4F17-9D2E-BCB10CB107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AE5A9-265B-4F1F-9F75-6F33983843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12B7E-FAD9-4BEC-AF6C-5C0AD8C8B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DA14AE-9259-4010-A625-2AA9E870029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0840" y="0"/>
            <a:ext cx="8593560" cy="3573000"/>
            <a:chOff x="240840" y="0"/>
            <a:chExt cx="8593560" cy="3573000"/>
          </a:xfrm>
        </p:grpSpPr>
        <p:grpSp>
          <p:nvGrpSpPr>
            <p:cNvPr id="42" name=""/>
            <p:cNvGrpSpPr/>
            <p:nvPr/>
          </p:nvGrpSpPr>
          <p:grpSpPr>
            <a:xfrm>
              <a:off x="685800" y="0"/>
              <a:ext cx="8135640" cy="3573000"/>
              <a:chOff x="685800" y="0"/>
              <a:chExt cx="8135640" cy="357300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685800" y="136440"/>
                <a:ext cx="8135640" cy="3436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 flipH="1">
                <a:off x="992520" y="0"/>
                <a:ext cx="75240" cy="3526200"/>
              </a:xfrm>
              <a:prstGeom prst="line">
                <a:avLst/>
              </a:prstGeom>
              <a:ln w="25560">
                <a:solidFill>
                  <a:srgbClr val="ff9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5" name=""/>
            <p:cNvSpPr/>
            <p:nvPr/>
          </p:nvSpPr>
          <p:spPr>
            <a:xfrm>
              <a:off x="8742240" y="26820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8742240" y="32688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8742240" y="44136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8742240" y="500040"/>
              <a:ext cx="92160" cy="586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1880" bIns="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8742240" y="55872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8742240" y="673200"/>
              <a:ext cx="92160" cy="568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080" bIns="10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8742240" y="730080"/>
              <a:ext cx="92160" cy="590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2240" bIns="122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742240" y="84780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8742240" y="905040"/>
              <a:ext cx="92160" cy="568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080" bIns="10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8742240" y="102060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8742240" y="1077840"/>
              <a:ext cx="92160" cy="586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1880" bIns="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8742240" y="113832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8742240" y="1251000"/>
              <a:ext cx="92160" cy="5868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1880" bIns="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8742240" y="131112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8742240" y="1368360"/>
              <a:ext cx="92160" cy="572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440" bIns="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241280" y="2351160"/>
              <a:ext cx="184320" cy="586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400" bIns="-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241280" y="2409840"/>
              <a:ext cx="184320" cy="586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400" bIns="-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241280" y="246852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241280" y="258444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241280" y="264168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241280" y="2757600"/>
              <a:ext cx="184320" cy="586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400" bIns="-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241280" y="281628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241280" y="2873520"/>
              <a:ext cx="184320" cy="554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7200" bIns="-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241280" y="2989440"/>
              <a:ext cx="184320" cy="56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480" bIns="-6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241280" y="3048120"/>
              <a:ext cx="184320" cy="56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480" bIns="-6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241280" y="316224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241280" y="3220920"/>
              <a:ext cx="184320" cy="572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6120" bIns="-6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629080" y="1425600"/>
              <a:ext cx="128520" cy="6048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640" bIns="-26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629080" y="1484280"/>
              <a:ext cx="128520" cy="6048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640" bIns="-26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629080" y="160020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629080" y="165744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629080" y="177336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629080" y="183024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629080" y="194796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629080" y="2004840"/>
              <a:ext cx="128520" cy="6048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6640" bIns="-26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629080" y="212076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629080" y="217800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629080" y="223668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629080" y="152280"/>
              <a:ext cx="128520" cy="61920"/>
            </a:xfrm>
            <a:prstGeom prst="triangle">
              <a:avLst>
                <a:gd name="adj" fmla="val 50000"/>
              </a:avLst>
            </a:prstGeom>
            <a:solidFill>
              <a:srgbClr val="3366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5920" bIns="-25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40840" y="304920"/>
              <a:ext cx="27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738600" y="2178000"/>
              <a:ext cx="26398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ubject #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152280" y="3716280"/>
            <a:ext cx="8767800" cy="2952720"/>
            <a:chOff x="152280" y="3716280"/>
            <a:chExt cx="8767800" cy="2952720"/>
          </a:xfrm>
        </p:grpSpPr>
        <p:pic>
          <p:nvPicPr>
            <p:cNvPr id="87" name="" descr=""/>
            <p:cNvPicPr/>
            <p:nvPr/>
          </p:nvPicPr>
          <p:blipFill>
            <a:blip r:embed="rId2"/>
            <a:stretch/>
          </p:blipFill>
          <p:spPr>
            <a:xfrm>
              <a:off x="849240" y="3828960"/>
              <a:ext cx="8070840" cy="2797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"/>
            <p:cNvSpPr/>
            <p:nvPr/>
          </p:nvSpPr>
          <p:spPr>
            <a:xfrm>
              <a:off x="3292560" y="3716280"/>
              <a:ext cx="0" cy="2952720"/>
            </a:xfrm>
            <a:prstGeom prst="line">
              <a:avLst/>
            </a:prstGeom>
            <a:ln w="255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448080" y="3871800"/>
              <a:ext cx="187200" cy="414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920" bIns="-16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448080" y="3956040"/>
              <a:ext cx="187200" cy="428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448080" y="4043520"/>
              <a:ext cx="187200" cy="410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7280" bIns="-172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448080" y="4170240"/>
              <a:ext cx="187200" cy="428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448080" y="4255920"/>
              <a:ext cx="187200" cy="432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840" bIns="-15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448080" y="4341960"/>
              <a:ext cx="187200" cy="428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448080" y="5668920"/>
              <a:ext cx="187200" cy="414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920" bIns="-16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448080" y="5753160"/>
              <a:ext cx="187200" cy="442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480" bIns="-15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448080" y="5881680"/>
              <a:ext cx="187200" cy="428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448080" y="5969160"/>
              <a:ext cx="187200" cy="410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7280" bIns="-172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448080" y="6053040"/>
              <a:ext cx="187200" cy="446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5120" bIns="-151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448080" y="6138720"/>
              <a:ext cx="187200" cy="414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920" bIns="-16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448080" y="6226200"/>
              <a:ext cx="187200" cy="414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920" bIns="-169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448080" y="6310440"/>
              <a:ext cx="187200" cy="4284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6200" bIns="-16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8734320" y="4470480"/>
              <a:ext cx="93600" cy="410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760" bIns="-5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8734320" y="455616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8734320" y="464184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8734320" y="477036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8734320" y="485460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8734320" y="494028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8734320" y="5068800"/>
              <a:ext cx="93600" cy="446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60" bIns="-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8734320" y="515448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8734320" y="5241960"/>
              <a:ext cx="93600" cy="414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400" bIns="-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8734320" y="532620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8734320" y="5452920"/>
              <a:ext cx="93600" cy="4284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960" bIns="-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8734320" y="5540400"/>
              <a:ext cx="93600" cy="414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400" bIns="-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118120" y="6010200"/>
              <a:ext cx="24098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ubject #2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52280" y="3809880"/>
              <a:ext cx="36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 Black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17" name=""/>
          <p:cNvSpPr/>
          <p:nvPr/>
        </p:nvSpPr>
        <p:spPr>
          <a:xfrm>
            <a:off x="3852360" y="357336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3709440" y="661356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9" name=""/>
          <p:cNvGrpSpPr/>
          <p:nvPr/>
        </p:nvGrpSpPr>
        <p:grpSpPr>
          <a:xfrm>
            <a:off x="317880" y="260280"/>
            <a:ext cx="7710120" cy="2952720"/>
            <a:chOff x="317880" y="260280"/>
            <a:chExt cx="7710120" cy="2952720"/>
          </a:xfrm>
        </p:grpSpPr>
        <p:pic>
          <p:nvPicPr>
            <p:cNvPr id="120" name="" descr=""/>
            <p:cNvPicPr/>
            <p:nvPr/>
          </p:nvPicPr>
          <p:blipFill>
            <a:blip r:embed="rId1"/>
            <a:stretch/>
          </p:blipFill>
          <p:spPr>
            <a:xfrm>
              <a:off x="826920" y="374760"/>
              <a:ext cx="7201080" cy="283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"/>
            <p:cNvSpPr/>
            <p:nvPr/>
          </p:nvSpPr>
          <p:spPr>
            <a:xfrm>
              <a:off x="317880" y="304920"/>
              <a:ext cx="27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767120" y="260280"/>
              <a:ext cx="0" cy="2948040"/>
            </a:xfrm>
            <a:prstGeom prst="line">
              <a:avLst/>
            </a:prstGeom>
            <a:ln w="255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7856640" y="797040"/>
              <a:ext cx="83880" cy="54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7856640" y="1709640"/>
              <a:ext cx="83880" cy="54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7856640" y="1871640"/>
              <a:ext cx="83880" cy="525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760" bIns="5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7856640" y="1978200"/>
              <a:ext cx="83880" cy="522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856640" y="2139840"/>
              <a:ext cx="83880" cy="54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856640" y="2246400"/>
              <a:ext cx="83880" cy="522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856640" y="2354400"/>
              <a:ext cx="83880" cy="522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856640" y="2516040"/>
              <a:ext cx="83880" cy="525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760" bIns="5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7856640" y="2622600"/>
              <a:ext cx="83880" cy="54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7856640" y="2782800"/>
              <a:ext cx="83880" cy="54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7856640" y="2892600"/>
              <a:ext cx="83880" cy="522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908680" y="422280"/>
              <a:ext cx="171360" cy="525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360" bIns="-9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908680" y="528480"/>
              <a:ext cx="171360" cy="525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360" bIns="-9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908680" y="690480"/>
              <a:ext cx="171360" cy="525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360" bIns="-9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5908680" y="906480"/>
              <a:ext cx="171360" cy="522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720" bIns="-97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908680" y="1066680"/>
              <a:ext cx="171360" cy="525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360" bIns="-9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908680" y="1173240"/>
              <a:ext cx="171360" cy="522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720" bIns="-97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908680" y="1333440"/>
              <a:ext cx="171360" cy="54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908680" y="1441440"/>
              <a:ext cx="171360" cy="525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9360" bIns="-93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908680" y="1601640"/>
              <a:ext cx="171360" cy="54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826920" y="2462040"/>
              <a:ext cx="23022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ubject #3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44" name=""/>
          <p:cNvGrpSpPr/>
          <p:nvPr/>
        </p:nvGrpSpPr>
        <p:grpSpPr>
          <a:xfrm>
            <a:off x="684360" y="3500280"/>
            <a:ext cx="7416720" cy="3024360"/>
            <a:chOff x="684360" y="3500280"/>
            <a:chExt cx="7416720" cy="3024360"/>
          </a:xfrm>
        </p:grpSpPr>
        <p:pic>
          <p:nvPicPr>
            <p:cNvPr id="145" name="" descr=""/>
            <p:cNvPicPr/>
            <p:nvPr/>
          </p:nvPicPr>
          <p:blipFill>
            <a:blip r:embed="rId2"/>
            <a:stretch/>
          </p:blipFill>
          <p:spPr>
            <a:xfrm>
              <a:off x="684360" y="3583080"/>
              <a:ext cx="7416720" cy="294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6" name=""/>
            <p:cNvSpPr/>
            <p:nvPr/>
          </p:nvSpPr>
          <p:spPr>
            <a:xfrm>
              <a:off x="2286000" y="3500280"/>
              <a:ext cx="0" cy="2997360"/>
            </a:xfrm>
            <a:prstGeom prst="line">
              <a:avLst/>
            </a:prstGeom>
            <a:ln w="255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7927920" y="3614760"/>
              <a:ext cx="84240" cy="507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7927920" y="3765600"/>
              <a:ext cx="84240" cy="507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7927920" y="3916440"/>
              <a:ext cx="84240" cy="489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160" bIns="2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7927920" y="4118040"/>
              <a:ext cx="84240" cy="493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" bIns="2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7927920" y="4267080"/>
              <a:ext cx="84240" cy="507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7927920" y="4417920"/>
              <a:ext cx="84240" cy="493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" bIns="2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7927920" y="4618080"/>
              <a:ext cx="84240" cy="507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792440" y="471960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792440" y="4919760"/>
              <a:ext cx="171360" cy="48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240" bIns="-122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792440" y="5068800"/>
              <a:ext cx="171360" cy="507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792440" y="521964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792440" y="537048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792440" y="5721480"/>
              <a:ext cx="171360" cy="507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792440" y="557208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792440" y="5870520"/>
              <a:ext cx="171360" cy="507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1792440" y="602280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792440" y="6173640"/>
              <a:ext cx="17136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730600" y="5219640"/>
              <a:ext cx="21304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ubject #6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5" name=""/>
          <p:cNvSpPr/>
          <p:nvPr/>
        </p:nvSpPr>
        <p:spPr>
          <a:xfrm>
            <a:off x="152280" y="3581280"/>
            <a:ext cx="45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Black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3726720" y="328464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3726720" y="656892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"/>
          <p:cNvSpPr/>
          <p:nvPr/>
        </p:nvSpPr>
        <p:spPr>
          <a:xfrm>
            <a:off x="242280" y="2286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 Black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9" name=""/>
          <p:cNvGrpSpPr/>
          <p:nvPr/>
        </p:nvGrpSpPr>
        <p:grpSpPr>
          <a:xfrm>
            <a:off x="838080" y="0"/>
            <a:ext cx="7632360" cy="2781000"/>
            <a:chOff x="838080" y="0"/>
            <a:chExt cx="7632360" cy="2781000"/>
          </a:xfrm>
        </p:grpSpPr>
        <p:pic>
          <p:nvPicPr>
            <p:cNvPr id="170" name="" descr=""/>
            <p:cNvPicPr/>
            <p:nvPr/>
          </p:nvPicPr>
          <p:blipFill>
            <a:blip r:embed="rId1"/>
            <a:stretch/>
          </p:blipFill>
          <p:spPr>
            <a:xfrm>
              <a:off x="838080" y="41760"/>
              <a:ext cx="7632360" cy="273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1" name=""/>
            <p:cNvSpPr/>
            <p:nvPr/>
          </p:nvSpPr>
          <p:spPr>
            <a:xfrm>
              <a:off x="8338680" y="45972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8338680" y="54972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8338680" y="68760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8338680" y="82404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8338680" y="91548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8338680" y="105156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8338680" y="114336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8338680" y="127872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8338680" y="141516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8338680" y="1506600"/>
              <a:ext cx="79920" cy="4500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483560" y="164304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483560" y="173448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483560" y="187092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483560" y="200736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483560" y="214380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483560" y="223524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483560" y="237168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1483560" y="250848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1483560" y="1320840"/>
              <a:ext cx="161640" cy="4500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1241640" y="0"/>
              <a:ext cx="0" cy="2723040"/>
            </a:xfrm>
            <a:prstGeom prst="line">
              <a:avLst/>
            </a:prstGeom>
            <a:ln w="25560">
              <a:solidFill>
                <a:srgbClr val="ff99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91" name=""/>
          <p:cNvSpPr/>
          <p:nvPr/>
        </p:nvSpPr>
        <p:spPr>
          <a:xfrm>
            <a:off x="3348000" y="1989000"/>
            <a:ext cx="1727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Arial"/>
              </a:rPr>
              <a:t>Subject #8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92" name=""/>
          <p:cNvGrpSpPr/>
          <p:nvPr/>
        </p:nvGrpSpPr>
        <p:grpSpPr>
          <a:xfrm>
            <a:off x="393840" y="3124080"/>
            <a:ext cx="8302320" cy="3229920"/>
            <a:chOff x="393840" y="3124080"/>
            <a:chExt cx="8302320" cy="3229920"/>
          </a:xfrm>
        </p:grpSpPr>
        <p:pic>
          <p:nvPicPr>
            <p:cNvPr id="193" name="" descr=""/>
            <p:cNvPicPr/>
            <p:nvPr/>
          </p:nvPicPr>
          <p:blipFill>
            <a:blip r:embed="rId2"/>
            <a:stretch/>
          </p:blipFill>
          <p:spPr>
            <a:xfrm>
              <a:off x="990720" y="3160800"/>
              <a:ext cx="7611840" cy="2844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4" name=""/>
            <p:cNvSpPr/>
            <p:nvPr/>
          </p:nvSpPr>
          <p:spPr>
            <a:xfrm>
              <a:off x="393840" y="3200400"/>
              <a:ext cx="25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Black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321600" y="3124080"/>
              <a:ext cx="0" cy="279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6086160" y="5894280"/>
              <a:ext cx="5191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</a:rPr>
                <a:t>T0</a:t>
              </a: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8624880" y="3867120"/>
              <a:ext cx="71280" cy="367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080" bIns="-100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8624880" y="4008600"/>
              <a:ext cx="71280" cy="34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8624880" y="4148280"/>
              <a:ext cx="71280" cy="331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3680" bIns="-13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8624880" y="4253040"/>
              <a:ext cx="71280" cy="331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3680" bIns="-13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8624880" y="4390920"/>
              <a:ext cx="71280" cy="34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8624880" y="4532400"/>
              <a:ext cx="71280" cy="34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8624880" y="4637160"/>
              <a:ext cx="71280" cy="34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8624880" y="4811760"/>
              <a:ext cx="71280" cy="3492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1880" bIns="-118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8624880" y="4950000"/>
              <a:ext cx="71280" cy="363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8624880" y="5054760"/>
              <a:ext cx="71280" cy="36360"/>
            </a:xfrm>
            <a:prstGeom prst="rect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537240" y="320364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6537240" y="334476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6537240" y="3484440"/>
              <a:ext cx="144720" cy="334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680" bIns="-22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6537240" y="362412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6537240" y="3728880"/>
              <a:ext cx="144720" cy="334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680" bIns="-22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6537240" y="519588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6537240" y="5335560"/>
              <a:ext cx="144720" cy="334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680" bIns="-22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6537240" y="5440320"/>
              <a:ext cx="144720" cy="334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2680" bIns="-226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6537240" y="557856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6537240" y="5719680"/>
              <a:ext cx="144720" cy="349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1960" bIns="-21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495440" y="5369040"/>
              <a:ext cx="2087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Arial"/>
                </a:rPr>
                <a:t>Subject #10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18" name=""/>
          <p:cNvSpPr/>
          <p:nvPr/>
        </p:nvSpPr>
        <p:spPr>
          <a:xfrm>
            <a:off x="3420360" y="285264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>
            <a:off x="3349080" y="6237360"/>
            <a:ext cx="98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</a:rPr>
              <a:t>months befor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7T10:56:06Z</dcterms:created>
  <dc:creator>FBernini</dc:creator>
  <dc:description/>
  <dc:language>en-US</dc:language>
  <cp:lastModifiedBy> </cp:lastModifiedBy>
  <dcterms:modified xsi:type="dcterms:W3CDTF">2010-08-12T11:05:51Z</dcterms:modified>
  <cp:revision>29</cp:revision>
  <dc:subject/>
  <dc:title>Presentazione di PowerPoint</dc:title>
</cp:coreProperties>
</file>